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1" d="100"/>
          <a:sy n="91" d="100"/>
        </p:scale>
        <p:origin x="178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CE7ABF9-5F98-4866-8B0F-C7CE58AF4348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D2DDDE-8F03-48FB-A1F9-5DD89E5AC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1554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D2DDDE-8F03-48FB-A1F9-5DD89E5ACD7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50610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AA556-71C8-4C96-9F57-E487D53C83D0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BCE82-6224-41DC-8B84-AFBB0DA1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3426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AA556-71C8-4C96-9F57-E487D53C83D0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BCE82-6224-41DC-8B84-AFBB0DA1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0203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AA556-71C8-4C96-9F57-E487D53C83D0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BCE82-6224-41DC-8B84-AFBB0DA1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008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AA556-71C8-4C96-9F57-E487D53C83D0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BCE82-6224-41DC-8B84-AFBB0DA1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7811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AA556-71C8-4C96-9F57-E487D53C83D0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BCE82-6224-41DC-8B84-AFBB0DA1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2269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AA556-71C8-4C96-9F57-E487D53C83D0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BCE82-6224-41DC-8B84-AFBB0DA1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4667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AA556-71C8-4C96-9F57-E487D53C83D0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BCE82-6224-41DC-8B84-AFBB0DA1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4915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AA556-71C8-4C96-9F57-E487D53C83D0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BCE82-6224-41DC-8B84-AFBB0DA1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0418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AA556-71C8-4C96-9F57-E487D53C83D0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BCE82-6224-41DC-8B84-AFBB0DA1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2550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AA556-71C8-4C96-9F57-E487D53C83D0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BCE82-6224-41DC-8B84-AFBB0DA1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39542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AA556-71C8-4C96-9F57-E487D53C83D0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BCE82-6224-41DC-8B84-AFBB0DA1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5187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6AA556-71C8-4C96-9F57-E487D53C83D0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EBCE82-6224-41DC-8B84-AFBB0DA13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5151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0"/>
            <a:ext cx="91440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US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19063"/>
            <a:r>
              <a:rPr lang="en-US" sz="1400" b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1 </a:t>
            </a:r>
            <a:endParaRPr lang="en-US" sz="1400" b="1" dirty="0" smtClean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19063"/>
            <a:endParaRPr lang="en-US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131781" y="432749"/>
            <a:ext cx="888043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ey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scriminatory genes representative of adaptive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10 </a:t>
            </a:r>
            <a:r>
              <a:rPr lang="el-G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μ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) versus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xicological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100 </a:t>
            </a:r>
            <a:r>
              <a:rPr lang="el-GR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μ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) response to Mn content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ox plots for representative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nes accounting for protein secretion pathway enrichment include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ET1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Golgi vesicular membrane trafficking protein),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AM10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Metallopeptidase Domain 10) and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RFGAP3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ADP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ibosylation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actor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TPase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ctivating Protein 3)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t 0, 10 and 100 </a:t>
            </a:r>
            <a:r>
              <a:rPr lang="el-GR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μ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 Mn (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Box plots for representative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nes accounting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r enrichment of oxidative phosphorylation pathway include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TP6V1H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ATPase H+ transporting V1 subunit H),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DUFAF5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NADH: Ubiquinone Oxidoreductase Complex Assembly Factor 5) and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ABP5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Fatty Acid Binding Protein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t 0, 10 and 100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μM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n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*</a:t>
            </a:r>
            <a:r>
              <a:rPr lang="en-US" sz="1200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&lt; 0.05, n=3)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1317089" y="2055071"/>
            <a:ext cx="1097280" cy="146304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507528" y="1772933"/>
            <a:ext cx="780294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ET1</a:t>
            </a:r>
            <a:endParaRPr lang="en-US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43407" y="2812658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9.6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967426" y="2248469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9.7</a:t>
            </a:r>
          </a:p>
        </p:txBody>
      </p:sp>
      <p:sp>
        <p:nvSpPr>
          <p:cNvPr id="8" name="Rectangle 7"/>
          <p:cNvSpPr/>
          <p:nvPr/>
        </p:nvSpPr>
        <p:spPr>
          <a:xfrm rot="16200000">
            <a:off x="251108" y="2424578"/>
            <a:ext cx="1107681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rmalized Expression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628634" y="2065827"/>
            <a:ext cx="1097280" cy="146304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3272412" y="2878557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8.7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252248" y="2285051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8.8</a:t>
            </a:r>
          </a:p>
        </p:txBody>
      </p:sp>
      <p:sp>
        <p:nvSpPr>
          <p:cNvPr id="12" name="Rectangle 11"/>
          <p:cNvSpPr/>
          <p:nvPr/>
        </p:nvSpPr>
        <p:spPr>
          <a:xfrm rot="16200000">
            <a:off x="2540073" y="2538663"/>
            <a:ext cx="110003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rmalized </a:t>
            </a:r>
            <a:r>
              <a:rPr lang="en-US" sz="14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en-US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3700812" y="1772933"/>
            <a:ext cx="102793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DAM10</a:t>
            </a:r>
            <a:endParaRPr lang="en-US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17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6116587" y="2065827"/>
            <a:ext cx="1097280" cy="1463040"/>
          </a:xfrm>
          <a:prstGeom prst="rect">
            <a:avLst/>
          </a:prstGeom>
        </p:spPr>
      </p:pic>
      <p:sp>
        <p:nvSpPr>
          <p:cNvPr id="19" name="Rectangle 18"/>
          <p:cNvSpPr/>
          <p:nvPr/>
        </p:nvSpPr>
        <p:spPr>
          <a:xfrm>
            <a:off x="6073048" y="1771038"/>
            <a:ext cx="121217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t-BR" sz="16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FGAP3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5750195" y="2934026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.7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5739421" y="2472630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.8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5750195" y="2019056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.9</a:t>
            </a:r>
          </a:p>
        </p:txBody>
      </p:sp>
      <p:sp>
        <p:nvSpPr>
          <p:cNvPr id="23" name="Rectangle 22"/>
          <p:cNvSpPr/>
          <p:nvPr/>
        </p:nvSpPr>
        <p:spPr>
          <a:xfrm rot="16200000">
            <a:off x="4933485" y="2422852"/>
            <a:ext cx="1203701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rmalized Expression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376539" y="3679131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nCl</a:t>
            </a:r>
            <a:r>
              <a:rPr lang="en-US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422592" y="3454884"/>
            <a:ext cx="2845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662251" y="3454884"/>
            <a:ext cx="3843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957144" y="3454884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Picture 31"/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1320431" y="4767377"/>
            <a:ext cx="1097280" cy="1463040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1402882" y="6406451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nCl</a:t>
            </a:r>
            <a:r>
              <a:rPr lang="en-US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1424225" y="6171015"/>
            <a:ext cx="2845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1674642" y="6171015"/>
            <a:ext cx="3843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1983770" y="6171015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ectangle 44"/>
          <p:cNvSpPr/>
          <p:nvPr/>
        </p:nvSpPr>
        <p:spPr>
          <a:xfrm>
            <a:off x="1314212" y="4469352"/>
            <a:ext cx="1140565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t-BR" sz="16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P6V1H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953155" y="5748023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.9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967506" y="4688506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.2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967506" y="5041678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.1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967506" y="5394850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.0</a:t>
            </a:r>
          </a:p>
        </p:txBody>
      </p:sp>
      <p:pic>
        <p:nvPicPr>
          <p:cNvPr id="50" name="Picture 49"/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658587" y="4767377"/>
            <a:ext cx="1097280" cy="1463040"/>
          </a:xfrm>
          <a:prstGeom prst="rect">
            <a:avLst/>
          </a:prstGeom>
        </p:spPr>
      </p:pic>
      <p:sp>
        <p:nvSpPr>
          <p:cNvPr id="51" name="Rectangle 50"/>
          <p:cNvSpPr/>
          <p:nvPr/>
        </p:nvSpPr>
        <p:spPr>
          <a:xfrm>
            <a:off x="3650934" y="4469352"/>
            <a:ext cx="1140565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t-BR" sz="16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DUFAF5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3272412" y="5533499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.9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3272412" y="4923478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.0</a:t>
            </a:r>
          </a:p>
        </p:txBody>
      </p:sp>
      <p:pic>
        <p:nvPicPr>
          <p:cNvPr id="54" name="Picture 53"/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6116587" y="4767377"/>
            <a:ext cx="1097280" cy="1463040"/>
          </a:xfrm>
          <a:prstGeom prst="rect">
            <a:avLst/>
          </a:prstGeom>
        </p:spPr>
      </p:pic>
      <p:sp>
        <p:nvSpPr>
          <p:cNvPr id="55" name="Rectangle 54"/>
          <p:cNvSpPr/>
          <p:nvPr/>
        </p:nvSpPr>
        <p:spPr>
          <a:xfrm>
            <a:off x="6242826" y="4469352"/>
            <a:ext cx="88470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t-BR" sz="16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BP5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5675694" y="5777021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.3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5675694" y="4921282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.4</a:t>
            </a:r>
          </a:p>
        </p:txBody>
      </p:sp>
      <p:sp>
        <p:nvSpPr>
          <p:cNvPr id="61" name="Rectangle 60"/>
          <p:cNvSpPr/>
          <p:nvPr/>
        </p:nvSpPr>
        <p:spPr>
          <a:xfrm rot="16200000">
            <a:off x="263240" y="5085257"/>
            <a:ext cx="1107681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rmalized Expression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3700812" y="3692321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nCl</a:t>
            </a:r>
            <a:r>
              <a:rPr lang="en-US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3746865" y="3468074"/>
            <a:ext cx="2845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3986524" y="3468074"/>
            <a:ext cx="3843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4281417" y="3468074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6197388" y="3669767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nCl</a:t>
            </a:r>
            <a:r>
              <a:rPr lang="en-US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6243441" y="3445520"/>
            <a:ext cx="2845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6483100" y="3445520"/>
            <a:ext cx="3843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6777993" y="3445520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3739196" y="6406451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nCl</a:t>
            </a:r>
            <a:r>
              <a:rPr lang="en-US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3760539" y="6171015"/>
            <a:ext cx="2845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4010956" y="6171015"/>
            <a:ext cx="3843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4320084" y="6171015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6218544" y="6384322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nCl</a:t>
            </a:r>
            <a:r>
              <a:rPr lang="en-US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6239887" y="6148886"/>
            <a:ext cx="2845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6490304" y="6148886"/>
            <a:ext cx="3843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6799432" y="6148886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Rectangle 81"/>
          <p:cNvSpPr/>
          <p:nvPr/>
        </p:nvSpPr>
        <p:spPr>
          <a:xfrm rot="16200000">
            <a:off x="2536248" y="5213513"/>
            <a:ext cx="1107681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rmalized Expression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Rectangle 82"/>
          <p:cNvSpPr/>
          <p:nvPr/>
        </p:nvSpPr>
        <p:spPr>
          <a:xfrm rot="16200000">
            <a:off x="4982069" y="5213514"/>
            <a:ext cx="1107681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rmalized Expression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flipH="1">
            <a:off x="1797938" y="2769842"/>
            <a:ext cx="1264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 flipH="1">
            <a:off x="6590389" y="2966546"/>
            <a:ext cx="1264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 flipH="1">
            <a:off x="4114072" y="2903563"/>
            <a:ext cx="1264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 flipH="1">
            <a:off x="6914441" y="5195566"/>
            <a:ext cx="1264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 flipH="1">
            <a:off x="2122249" y="5107323"/>
            <a:ext cx="1264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 flipH="1">
            <a:off x="4445180" y="4901099"/>
            <a:ext cx="1264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46771" y="17054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270833" y="4314451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2709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5</TotalTime>
  <Words>220</Words>
  <Application>Microsoft Office PowerPoint</Application>
  <PresentationFormat>On-screen Show (4:3)</PresentationFormat>
  <Paragraphs>6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Emory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ernandes, Jolyn</dc:creator>
  <cp:lastModifiedBy>Fernandes, Jolyn</cp:lastModifiedBy>
  <cp:revision>33</cp:revision>
  <dcterms:created xsi:type="dcterms:W3CDTF">2019-03-07T22:12:31Z</dcterms:created>
  <dcterms:modified xsi:type="dcterms:W3CDTF">2019-07-09T15:11:46Z</dcterms:modified>
</cp:coreProperties>
</file>